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2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29713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36356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69730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89969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50244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22250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82753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014190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93785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8795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77578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7A2D49-4992-4D21-847D-57188F585D1D}" type="datetimeFigureOut">
              <a:rPr lang="fi-FI" smtClean="0"/>
              <a:t>13.12.2023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4C3C9-D40D-41FA-ADC2-B92B3BB212C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61821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13993" y="579057"/>
            <a:ext cx="4905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000" b="1" dirty="0"/>
              <a:t>Supplemental </a:t>
            </a:r>
            <a:r>
              <a:rPr lang="fi-FI" sz="1000" b="1" dirty="0" err="1"/>
              <a:t>Figure</a:t>
            </a:r>
            <a:r>
              <a:rPr lang="fi-FI" sz="1000" b="1"/>
              <a:t> </a:t>
            </a:r>
            <a:r>
              <a:rPr lang="fi-FI" sz="1000" b="1" smtClean="0"/>
              <a:t>3. </a:t>
            </a:r>
            <a:r>
              <a:rPr lang="en-US" sz="1000" b="1" dirty="0"/>
              <a:t>Metabolic measures included in each PMRS and their variable </a:t>
            </a:r>
          </a:p>
          <a:p>
            <a:r>
              <a:rPr lang="en-US" sz="1000" b="1" dirty="0"/>
              <a:t>importance for the projection values</a:t>
            </a:r>
            <a:r>
              <a:rPr lang="fi-FI" sz="1000" b="1" dirty="0"/>
              <a:t> </a:t>
            </a:r>
          </a:p>
        </p:txBody>
      </p:sp>
      <p:sp>
        <p:nvSpPr>
          <p:cNvPr id="18" name="Right Brace 17"/>
          <p:cNvSpPr/>
          <p:nvPr/>
        </p:nvSpPr>
        <p:spPr>
          <a:xfrm>
            <a:off x="3814264" y="1504606"/>
            <a:ext cx="415447" cy="7417135"/>
          </a:xfrm>
          <a:prstGeom prst="righ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640636" y="8927144"/>
            <a:ext cx="3148990" cy="542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ight Brace 25"/>
          <p:cNvSpPr/>
          <p:nvPr/>
        </p:nvSpPr>
        <p:spPr>
          <a:xfrm>
            <a:off x="4552803" y="1504607"/>
            <a:ext cx="389835" cy="5013524"/>
          </a:xfrm>
          <a:prstGeom prst="righ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619632" y="6526745"/>
            <a:ext cx="3956589" cy="19213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ight Brace 29"/>
          <p:cNvSpPr/>
          <p:nvPr/>
        </p:nvSpPr>
        <p:spPr>
          <a:xfrm>
            <a:off x="5322395" y="1504607"/>
            <a:ext cx="337420" cy="2922566"/>
          </a:xfrm>
          <a:prstGeom prst="righ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cxnSp>
        <p:nvCxnSpPr>
          <p:cNvPr id="31" name="Straight Connector 30"/>
          <p:cNvCxnSpPr/>
          <p:nvPr/>
        </p:nvCxnSpPr>
        <p:spPr>
          <a:xfrm>
            <a:off x="649156" y="4427172"/>
            <a:ext cx="4673239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ight Brace 31"/>
          <p:cNvSpPr/>
          <p:nvPr/>
        </p:nvSpPr>
        <p:spPr>
          <a:xfrm>
            <a:off x="6083842" y="1504607"/>
            <a:ext cx="177807" cy="1857152"/>
          </a:xfrm>
          <a:prstGeom prst="rightBrac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cxnSp>
        <p:nvCxnSpPr>
          <p:cNvPr id="33" name="Straight Connector 32"/>
          <p:cNvCxnSpPr/>
          <p:nvPr/>
        </p:nvCxnSpPr>
        <p:spPr>
          <a:xfrm>
            <a:off x="649156" y="3361759"/>
            <a:ext cx="5469849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-5400000">
            <a:off x="3368550" y="7610739"/>
            <a:ext cx="8963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MRS/BMI all</a:t>
            </a:r>
            <a:endParaRPr lang="fi-FI" sz="1000" dirty="0"/>
          </a:p>
        </p:txBody>
      </p:sp>
      <p:sp>
        <p:nvSpPr>
          <p:cNvPr id="35" name="TextBox 34"/>
          <p:cNvSpPr txBox="1"/>
          <p:nvPr/>
        </p:nvSpPr>
        <p:spPr>
          <a:xfrm rot="-5400000">
            <a:off x="3982775" y="5259272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MRS/BMI VIP 1.0</a:t>
            </a:r>
            <a:endParaRPr lang="fi-FI" sz="1000" dirty="0"/>
          </a:p>
        </p:txBody>
      </p:sp>
      <p:sp>
        <p:nvSpPr>
          <p:cNvPr id="36" name="TextBox 35"/>
          <p:cNvSpPr txBox="1"/>
          <p:nvPr/>
        </p:nvSpPr>
        <p:spPr>
          <a:xfrm rot="-5400000">
            <a:off x="4653895" y="3788170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MRS/BMI VIP 1.2</a:t>
            </a:r>
            <a:endParaRPr lang="fi-FI" sz="1000" dirty="0"/>
          </a:p>
        </p:txBody>
      </p:sp>
      <p:sp>
        <p:nvSpPr>
          <p:cNvPr id="37" name="TextBox 36"/>
          <p:cNvSpPr txBox="1"/>
          <p:nvPr/>
        </p:nvSpPr>
        <p:spPr>
          <a:xfrm rot="-5400000">
            <a:off x="5390704" y="2069141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MRS/BMI VIP 1.4</a:t>
            </a:r>
            <a:endParaRPr lang="fi-FI" sz="10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5350537"/>
              </p:ext>
            </p:extLst>
          </p:nvPr>
        </p:nvGraphicFramePr>
        <p:xfrm>
          <a:off x="649156" y="1169553"/>
          <a:ext cx="3104413" cy="7752188"/>
        </p:xfrm>
        <a:graphic>
          <a:graphicData uri="http://schemas.openxmlformats.org/drawingml/2006/table">
            <a:tbl>
              <a:tblPr/>
              <a:tblGrid>
                <a:gridCol w="2031173">
                  <a:extLst>
                    <a:ext uri="{9D8B030D-6E8A-4147-A177-3AD203B41FA5}">
                      <a16:colId xmlns:a16="http://schemas.microsoft.com/office/drawing/2014/main" val="1624837678"/>
                    </a:ext>
                  </a:extLst>
                </a:gridCol>
                <a:gridCol w="1073240">
                  <a:extLst>
                    <a:ext uri="{9D8B030D-6E8A-4147-A177-3AD203B41FA5}">
                      <a16:colId xmlns:a16="http://schemas.microsoft.com/office/drawing/2014/main" val="3549296499"/>
                    </a:ext>
                  </a:extLst>
                </a:gridCol>
              </a:tblGrid>
              <a:tr h="342212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bolic measur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 importance for the projection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920476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protein</a:t>
                      </a:r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i-FI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tyls</a:t>
                      </a:r>
                      <a:endParaRPr lang="fi-FI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2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95839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PUFA to MU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257476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MUFA to 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180823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PUFA to 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334660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omega-6 FA to 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3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5952278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linoleic acid to 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0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032083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toacet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9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703430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r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0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81920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nounsaturated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17475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-Hydroxybutyr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1251986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s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291997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extremely large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32455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very large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34533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bumin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3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019260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triglycerides to phosphoglycerid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9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89189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triglycerid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8854735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large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618386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glycerides in V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5000035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lipids in V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853863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yruv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364033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diameter for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510751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ospholipids in V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1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64714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diameter for H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9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251756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8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137545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ee cholesterol in V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981848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tid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236766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31342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small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5157474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turated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15628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m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007760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LDL cholestero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38375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large H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8494768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632872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docosahexaenoic acid to total F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336566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lesteryl esters in H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6393393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L cholestero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09468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t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500765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oleuc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9602151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very large H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1821498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lesteryl esters in V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704996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glycerides in L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5050716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glycerides in H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283413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medium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5999295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saturation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756053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os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033678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i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605510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io of apolipoprotein B to apolipoprotein A1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443118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tat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82542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concentration of branched-chain AA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84013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very small V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857256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medium 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741423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centration of small H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1190359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diameter for LDL particles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3881402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mnant cholesterol (non-HDL, non-LDL)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447033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tone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2872717"/>
                  </a:ext>
                </a:extLst>
              </a:tr>
              <a:tr h="132321">
                <a:tc>
                  <a:txBody>
                    <a:bodyPr/>
                    <a:lstStyle/>
                    <a:p>
                      <a:pPr algn="l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ee cholesterol in HDL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3699" marR="3699" marT="3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076527"/>
                  </a:ext>
                </a:extLst>
              </a:tr>
            </a:tbl>
          </a:graphicData>
        </a:graphic>
      </p:graphicFrame>
      <p:cxnSp>
        <p:nvCxnSpPr>
          <p:cNvPr id="19" name="Straight Connector 18"/>
          <p:cNvCxnSpPr/>
          <p:nvPr/>
        </p:nvCxnSpPr>
        <p:spPr>
          <a:xfrm>
            <a:off x="649156" y="1504606"/>
            <a:ext cx="5469849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4245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7</TotalTime>
  <Words>289</Words>
  <Application>Microsoft Office PowerPoint</Application>
  <PresentationFormat>A4 Paper (210x297 mm)</PresentationFormat>
  <Paragraphs>1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Helsink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chenko, Polina</dc:creator>
  <cp:lastModifiedBy>Girchenko, Polina</cp:lastModifiedBy>
  <cp:revision>19</cp:revision>
  <dcterms:created xsi:type="dcterms:W3CDTF">2022-06-10T08:26:11Z</dcterms:created>
  <dcterms:modified xsi:type="dcterms:W3CDTF">2023-12-13T09:06:13Z</dcterms:modified>
</cp:coreProperties>
</file>